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8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C58311A-7FC2-9B9B-2B4B-C847A289B08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3668CBD-6BA3-9F77-27FC-A67AFBCA126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B305E06-3D93-6DFC-C0B0-DFF616AF50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3FFA1-2D72-4FCD-BDD5-5FC3287ACBC0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933E1E9-8B05-38CD-8AC5-877AF8C251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3F44B8A-FAF0-A740-A4CF-2DD68A6806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8669A-4B17-4B64-A9FB-E2BF5FD100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32628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9ED42A1-BD21-82A7-F06B-3D949A404C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BF9D095-37DB-9EF0-F4CE-E993554172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AD1DA88-BB60-04E0-C02D-C485DB407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3FFA1-2D72-4FCD-BDD5-5FC3287ACBC0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8514637-DB15-98F3-908E-1D959275B2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D2807AA-EB74-4436-84D9-3C1D2C7256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8669A-4B17-4B64-A9FB-E2BF5FD100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2167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01EBE20-6C0F-ABE5-395A-DA30675E3F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6E23064-E7B1-D5C4-E28D-D52D6730B6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B5A6BAD-9D54-6779-974F-3EA8B5A5E5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3FFA1-2D72-4FCD-BDD5-5FC3287ACBC0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BCB740C-3FFE-5025-8549-D114A0AD51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B06529B-A594-B91B-576A-BFFF9598B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8669A-4B17-4B64-A9FB-E2BF5FD100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5880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CDB0F4-605C-DA5A-016A-1D28E3473A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2E265EA-5404-0014-81B5-D1AC55EFC1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7718D77-C507-2887-9662-93A2B59877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3FFA1-2D72-4FCD-BDD5-5FC3287ACBC0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25C3E00-FED7-6F62-4BE5-6B62D9C2D3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A43C7DA-3201-5B1C-889C-A283381E06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8669A-4B17-4B64-A9FB-E2BF5FD100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76320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F3CF509-88C7-BC12-5D90-CB843E3201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16A1CC8-4002-15F5-28C6-C9CFFF228F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90E43D1-A03E-008C-7261-58B3F0F787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3FFA1-2D72-4FCD-BDD5-5FC3287ACBC0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E386CDB-8906-B03A-D1D2-126B2A4286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C9A5CE2-07BF-FF88-82ED-8898007065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8669A-4B17-4B64-A9FB-E2BF5FD100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7294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33CD4F3-CFFC-BF4F-8CD8-BEE0067A07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370203F-B321-FE7C-1731-9019ED4332F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FCE8AD0-B25E-46E3-A5A2-D5101B6E82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534D5F4-AFC9-2D72-64F9-7171150B6C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3FFA1-2D72-4FCD-BDD5-5FC3287ACBC0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5499CED-1955-42FC-9BBE-4313D5FEBA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28A262B-43FA-AB5E-5B7A-CE169C41D1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8669A-4B17-4B64-A9FB-E2BF5FD100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8456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AB4AA0-67D9-C5C0-2852-9D830FFF7A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6BC0424-C63B-418B-6F1E-5FC1731DFF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6B176E6-3888-7588-E947-BBD1156F0A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58B72F7-7BA6-4AF3-E716-8A14476577D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0130638-9C93-E457-9818-D37CA800E5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C4791C2-26EA-068B-BB8E-E1842D373A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3FFA1-2D72-4FCD-BDD5-5FC3287ACBC0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80BCE65-4E57-BB2C-B4DC-3AD30248AF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D72D83E-52B5-0C90-AF50-5DD7EC482A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8669A-4B17-4B64-A9FB-E2BF5FD100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5860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21741E2-4DBD-F631-08E4-AFCFBDB8C5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AF5CFFA-443F-AAC2-C5B2-D341B2E055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3FFA1-2D72-4FCD-BDD5-5FC3287ACBC0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D9C5616-0065-A430-59BE-29B6EA07AD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94D6288-5115-E237-3385-5DA77D0D53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8669A-4B17-4B64-A9FB-E2BF5FD100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46546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B69D0BC-4067-EF89-2545-1095715B81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3FFA1-2D72-4FCD-BDD5-5FC3287ACBC0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00D1670-C4BC-F2F0-1139-D4E58922D9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97C8040-AE2D-679B-4A22-AD2E174806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8669A-4B17-4B64-A9FB-E2BF5FD100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7838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3CCDD86-A5DE-C3DB-130D-C2C6F8D2F8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ADDC82A-79E1-FE5E-0D51-7EA2BBB46B7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F181A44-71AA-CE5D-C222-023164A366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BD90773-C750-ABA5-4E14-344C9CEBE0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3FFA1-2D72-4FCD-BDD5-5FC3287ACBC0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AF77224-2264-7658-385A-DB1242959F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91A019D-8778-FAA2-2CCD-E3247ACFEC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8669A-4B17-4B64-A9FB-E2BF5FD100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14179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835F5AD-31D1-6125-7C0C-D33EA7B2CC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1B884C6-F27F-FAE7-91FA-CCD9D83158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EAEB8B4-EED6-50CC-4A00-BF0EB930FF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2D3F8F4-5AF0-034B-03C2-DA59C91B9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3FFA1-2D72-4FCD-BDD5-5FC3287ACBC0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8EA75E5-20B9-6E2F-0ECB-26478A8B4F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2507B20-EA08-C9D3-4D9D-EB63476E2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8669A-4B17-4B64-A9FB-E2BF5FD100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63172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D3BF9DD-6A7C-B8DA-ABA5-7802536631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681FE7F-EA6A-2335-444C-9C684B91AA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E76EC15-7182-A2F1-1AD1-6F10C842C64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83FFA1-2D72-4FCD-BDD5-5FC3287ACBC0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B5637CE-7328-22F5-B23B-E51CB4BCFA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D7B6612-6263-AD6E-B8B5-8B6BCDE9C5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88669A-4B17-4B64-A9FB-E2BF5FD100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8373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F700BE03-ACE7-F44B-33FF-AEE560D48CD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1087" y="1583436"/>
            <a:ext cx="10533757" cy="3100324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90C782CD-C1EE-0071-F221-6F979B833F94}"/>
              </a:ext>
            </a:extLst>
          </p:cNvPr>
          <p:cNvSpPr txBox="1"/>
          <p:nvPr/>
        </p:nvSpPr>
        <p:spPr>
          <a:xfrm>
            <a:off x="1391920" y="4968240"/>
            <a:ext cx="9235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1  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等线" panose="02010600030101010101" pitchFamily="2" charset="-122"/>
              </a:rPr>
              <a:t>Flow cytometry plots on the gating strategy to identify MDSCs.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531358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F1613EE-DDA9-93C3-5E48-FF688A64521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928" y="99568"/>
            <a:ext cx="6687312" cy="6687312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8F91750E-24A8-1808-F3BC-A20F6A3A2AA9}"/>
              </a:ext>
            </a:extLst>
          </p:cNvPr>
          <p:cNvSpPr txBox="1"/>
          <p:nvPr/>
        </p:nvSpPr>
        <p:spPr>
          <a:xfrm>
            <a:off x="1026160" y="4968240"/>
            <a:ext cx="923544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2  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rPr>
              <a:t>Effect of MDSCs on the proliferation of CD4+ T-cells.</a:t>
            </a:r>
            <a:r>
              <a:rPr lang="en-US" altLang="zh-CN" sz="1800" b="1" kern="100" dirty="0">
                <a:effectLst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rPr>
              <a:t> 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rPr>
              <a:t>In the presence of anti-CD3/CD28 beads, sorted CD4+ T-cells from 10 INRs were cocultured with autologous PMN-MDSCs at different ratios (2:1, 4:1, 8:1) for 4 days. The proliferation of CD4+ T-cells was analyzed with CFSE labeling. Unstimulated CD4+ T-cells were used as negative control.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29806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85</Words>
  <Application>Microsoft Office PowerPoint</Application>
  <PresentationFormat>宽屏</PresentationFormat>
  <Paragraphs>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uan xia</dc:creator>
  <cp:lastModifiedBy>huan xia</cp:lastModifiedBy>
  <cp:revision>6</cp:revision>
  <dcterms:created xsi:type="dcterms:W3CDTF">2024-11-25T13:21:08Z</dcterms:created>
  <dcterms:modified xsi:type="dcterms:W3CDTF">2024-11-25T13:29:38Z</dcterms:modified>
</cp:coreProperties>
</file>